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70" r:id="rId2"/>
    <p:sldId id="28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4972"/>
  </p:normalViewPr>
  <p:slideViewPr>
    <p:cSldViewPr snapToGrid="0" snapToObjects="1">
      <p:cViewPr varScale="1">
        <p:scale>
          <a:sx n="87" d="100"/>
          <a:sy n="87" d="100"/>
        </p:scale>
        <p:origin x="90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262CA7-79D9-804A-8007-88E789A2DCD5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6562F0-F314-3246-AE0A-E8B638C57A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4304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856E54-7951-4F3B-AD48-7B660C666670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2472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294175-2164-6249-B647-39784177ED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CDCA47-CA03-2B4B-9AF9-C694C4DE4A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7DFEC8-EC2D-ED4E-84E7-E0F53B1FE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D6038C-1EAE-3444-8A20-DD66ED6DB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9625FF-84E4-074F-9689-7DC947B0C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16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1EFFD2-B825-E442-9FDA-8BB453F299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6BAE46-6375-CE47-8F8F-0B78C28EEE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ADFBA4-EBC8-8146-B4E1-CFE2356CC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6A37D5-2CFE-994D-8380-E97C99865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7F2E58-0872-9640-A262-751A0F144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678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2A25737-2573-284D-838A-37AEA19A9A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DF74D4-ED43-2845-A140-1F4C300691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947417-8CD5-1742-B755-889EF1D9A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13C9DA-9B09-DE4C-91F8-593701790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5F8B5A-8508-7343-8551-9768D79F5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850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B40786-F8C8-0E49-865A-17D775F186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7A6AE3-0C86-DC49-A282-D972BD40D7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759083-DD2D-1342-A52D-32588A754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7BE48C-DC0A-E440-B02D-1BC1F0DBA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BD02E5-DAA9-1047-95FE-6D5BDC365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417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ABBAF4-D845-754B-91E5-0CC737AC3B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207114-5653-CD40-9B1A-F1B81AFF52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7B431C-6D63-F041-8C0A-B55E6034D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6CA6C8-BC1C-7646-A3F6-AE8904126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2A58D-D744-7E44-97DD-86FECF78A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705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4FC2EE-33F5-F54C-8AD8-052A9B8FC6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A49D9B-2772-2D4E-AA96-29B005CB11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71B823-9212-254C-8D80-EFE15EA310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85034B-3167-EC4A-8BAD-A99747C0F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97CA18-AB9E-F74A-A51B-FB4CB0899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6F72B7-6E8B-084C-9781-4F9B3FA00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29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7C157-E641-EA46-8C65-13A4FBF7C0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CBB2C4-0D11-114E-9E4F-96F8701E8B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85A9D6-D09A-F14C-8689-2E2C72B15E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AA50E5-A205-9744-A9A6-B8E8D2D056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1E64E4-0A5F-D24C-9472-7599C4FB8D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FE6F0F-5AC7-654F-B122-34786F46A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E5B689-D76F-AC4E-8CB0-EB9B6617C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3A69D2-D8C6-5745-A115-CA8C97AA2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831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96D263-5245-F646-AC77-8077F7BD1B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826B2B-DF30-4C43-8D1E-8D50999D9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0E576D-6B3B-2C41-884A-5D610C547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4855C3-B078-644E-AEA1-19CEA93F3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745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DC9788-EF4F-F643-8BB9-8FCED9C86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D41F4D-F10C-8641-A437-D4332770F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4D475B-E025-5F42-B720-FE44B68C0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048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917729-662D-8F49-8F2A-8D9952761B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067779-DED6-4945-967E-75F2987DA2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A432C2-10AE-FA43-BF8A-5D6CBFD597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C62FFC-AD1C-5043-B4A1-77046695C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254133-29F4-B64C-9FA5-AD594EC9F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114B16-7204-CE4B-81B2-C0888C4E4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655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4F751-7A11-454B-B418-41F02B403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21451C-BE16-3F48-B720-8F78BC5552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30F385-1415-0945-ABCE-1EAAAABE48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7E33F3-2043-9B41-B29F-F7BC39AA1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116133-16EB-E542-AD63-227B60774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CB8028-346C-AB43-8A34-EED563F92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161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67C07B-9B01-FE43-9366-4DF11317A6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EBD223-45BA-8644-B17D-39F4FB19A7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9A0EAF-CD0A-A848-BAB6-62EDCED3B3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AEA74A-F6BB-074B-95A3-E9CB6707CF4F}" type="datetimeFigureOut">
              <a:rPr lang="en-US" smtClean="0"/>
              <a:t>12/23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77EBC6-2EB5-B141-8424-2172E63EE9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3C0215-E457-7045-BF18-224FDE1930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1F4A4-63CC-4247-B2EC-FDF6C26D0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394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4" t="41746" r="30665" b="31949"/>
          <a:stretch/>
        </p:blipFill>
        <p:spPr bwMode="auto">
          <a:xfrm>
            <a:off x="3115398" y="969788"/>
            <a:ext cx="5312171" cy="11630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9"/>
          <p:cNvSpPr txBox="1"/>
          <p:nvPr/>
        </p:nvSpPr>
        <p:spPr>
          <a:xfrm>
            <a:off x="2543048" y="932726"/>
            <a:ext cx="497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5" name="TextBox 27"/>
          <p:cNvSpPr txBox="1"/>
          <p:nvPr/>
        </p:nvSpPr>
        <p:spPr>
          <a:xfrm>
            <a:off x="2262632" y="299695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16" name="Picture 28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2791722" y="3107763"/>
            <a:ext cx="5791590" cy="1429246"/>
          </a:xfrm>
          <a:prstGeom prst="rect">
            <a:avLst/>
          </a:prstGeom>
        </p:spPr>
      </p:pic>
      <p:sp>
        <p:nvSpPr>
          <p:cNvPr id="17" name="TextBox 5">
            <a:extLst>
              <a:ext uri="{FF2B5EF4-FFF2-40B4-BE49-F238E27FC236}">
                <a16:creationId xmlns:a16="http://schemas.microsoft.com/office/drawing/2014/main" id="{A5B79343-9DA8-7B42-A65C-8554B433A02F}"/>
              </a:ext>
            </a:extLst>
          </p:cNvPr>
          <p:cNvSpPr txBox="1"/>
          <p:nvPr/>
        </p:nvSpPr>
        <p:spPr>
          <a:xfrm>
            <a:off x="1917431" y="5120024"/>
            <a:ext cx="842751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ure 1.</a:t>
            </a:r>
            <a:r>
              <a:rPr lang="en-US" dirty="0"/>
              <a:t> Generation of COMMD1 KO cell line from H460. A) A functional cassette was inserted by homology-</a:t>
            </a:r>
            <a:r>
              <a:rPr lang="en-US" dirty="0" err="1"/>
              <a:t>dependant</a:t>
            </a:r>
            <a:r>
              <a:rPr lang="en-US" dirty="0"/>
              <a:t> CRISPR/Cas9 in </a:t>
            </a:r>
            <a:r>
              <a:rPr lang="es-UY" dirty="0"/>
              <a:t>H460. </a:t>
            </a:r>
            <a:r>
              <a:rPr lang="en-US" dirty="0"/>
              <a:t>Insertion</a:t>
            </a:r>
            <a:r>
              <a:rPr lang="es-UY" dirty="0"/>
              <a:t> at </a:t>
            </a:r>
            <a:r>
              <a:rPr lang="es-UY" dirty="0" err="1"/>
              <a:t>the</a:t>
            </a:r>
            <a:r>
              <a:rPr lang="es-UY" dirty="0"/>
              <a:t> target </a:t>
            </a:r>
            <a:r>
              <a:rPr lang="es-UY" dirty="0" err="1"/>
              <a:t>site</a:t>
            </a:r>
            <a:r>
              <a:rPr lang="es-UY" dirty="0"/>
              <a:t> </a:t>
            </a:r>
            <a:r>
              <a:rPr lang="es-UY" dirty="0" err="1"/>
              <a:t>was</a:t>
            </a:r>
            <a:r>
              <a:rPr lang="es-UY" dirty="0"/>
              <a:t> </a:t>
            </a:r>
            <a:r>
              <a:rPr lang="en-US" dirty="0"/>
              <a:t>verified by </a:t>
            </a:r>
            <a:r>
              <a:rPr lang="es-UY" dirty="0"/>
              <a:t>B) </a:t>
            </a:r>
            <a:r>
              <a:rPr lang="en-US" dirty="0"/>
              <a:t>Sanger sequencing</a:t>
            </a:r>
            <a:r>
              <a:rPr lang="es-UY" dirty="0"/>
              <a:t>. </a:t>
            </a:r>
            <a:endParaRPr lang="en-US" dirty="0"/>
          </a:p>
        </p:txBody>
      </p:sp>
      <p:sp>
        <p:nvSpPr>
          <p:cNvPr id="18" name="CuadroTexto 17"/>
          <p:cNvSpPr txBox="1"/>
          <p:nvPr/>
        </p:nvSpPr>
        <p:spPr>
          <a:xfrm>
            <a:off x="4079776" y="1855347"/>
            <a:ext cx="1431802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/>
              <a:t>Left integration </a:t>
            </a:r>
            <a:r>
              <a:rPr lang="en-US" sz="1100" dirty="0" err="1"/>
              <a:t>oligos</a:t>
            </a:r>
            <a:endParaRPr lang="en-US" sz="1100" dirty="0"/>
          </a:p>
        </p:txBody>
      </p:sp>
      <p:sp>
        <p:nvSpPr>
          <p:cNvPr id="19" name="CuadroTexto 18"/>
          <p:cNvSpPr txBox="1"/>
          <p:nvPr/>
        </p:nvSpPr>
        <p:spPr>
          <a:xfrm>
            <a:off x="5591944" y="1855677"/>
            <a:ext cx="1507144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/>
              <a:t>Right integration </a:t>
            </a:r>
            <a:r>
              <a:rPr lang="en-US" sz="1100" dirty="0" err="1"/>
              <a:t>oligos</a:t>
            </a:r>
            <a:endParaRPr lang="en-US" sz="1100" dirty="0"/>
          </a:p>
        </p:txBody>
      </p:sp>
      <p:sp>
        <p:nvSpPr>
          <p:cNvPr id="20" name="CuadroTexto 19"/>
          <p:cNvSpPr txBox="1"/>
          <p:nvPr/>
        </p:nvSpPr>
        <p:spPr>
          <a:xfrm>
            <a:off x="5079122" y="865136"/>
            <a:ext cx="1160895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/>
              <a:t>Inserted cassette</a:t>
            </a:r>
          </a:p>
        </p:txBody>
      </p:sp>
      <p:sp>
        <p:nvSpPr>
          <p:cNvPr id="21" name="20 Rectángulo"/>
          <p:cNvSpPr/>
          <p:nvPr/>
        </p:nvSpPr>
        <p:spPr>
          <a:xfrm>
            <a:off x="7248128" y="188640"/>
            <a:ext cx="32592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Palatino Linotype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 Figure 1. </a:t>
            </a:r>
            <a:r>
              <a:rPr lang="en-US" dirty="0" err="1">
                <a:solidFill>
                  <a:srgbClr val="000000"/>
                </a:solidFill>
                <a:latin typeface="Palatino Linotype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ghero</a:t>
            </a:r>
            <a:r>
              <a:rPr lang="en-US" dirty="0">
                <a:solidFill>
                  <a:srgbClr val="000000"/>
                </a:solidFill>
                <a:latin typeface="Palatino Linotype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t al</a:t>
            </a:r>
            <a:endParaRPr lang="es-ES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5070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20 Rectángulo">
            <a:extLst>
              <a:ext uri="{FF2B5EF4-FFF2-40B4-BE49-F238E27FC236}">
                <a16:creationId xmlns:a16="http://schemas.microsoft.com/office/drawing/2014/main" id="{34CAA146-E2D5-3F40-858E-1803E5610456}"/>
              </a:ext>
            </a:extLst>
          </p:cNvPr>
          <p:cNvSpPr/>
          <p:nvPr/>
        </p:nvSpPr>
        <p:spPr>
          <a:xfrm>
            <a:off x="7248129" y="188640"/>
            <a:ext cx="31438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Palatino Linotype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 Figure 2. </a:t>
            </a:r>
            <a:r>
              <a:rPr lang="en-US" dirty="0" err="1">
                <a:solidFill>
                  <a:srgbClr val="000000"/>
                </a:solidFill>
                <a:latin typeface="Palatino Linotype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ghero</a:t>
            </a:r>
            <a:r>
              <a:rPr lang="en-US" dirty="0">
                <a:solidFill>
                  <a:srgbClr val="000000"/>
                </a:solidFill>
                <a:latin typeface="Palatino Linotype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t al</a:t>
            </a:r>
            <a:endParaRPr lang="es-ES" dirty="0">
              <a:latin typeface="Palatino Linotype" pitchFamily="18" charset="0"/>
            </a:endParaRPr>
          </a:p>
        </p:txBody>
      </p:sp>
      <p:pic>
        <p:nvPicPr>
          <p:cNvPr id="3" name="Picture 2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3D88842F-1EDB-D743-A94D-714D8CCC5BB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7528" y="188641"/>
            <a:ext cx="6048672" cy="4366689"/>
          </a:xfrm>
          <a:prstGeom prst="rect">
            <a:avLst/>
          </a:prstGeom>
        </p:spPr>
      </p:pic>
      <p:sp>
        <p:nvSpPr>
          <p:cNvPr id="4" name="TextBox 5">
            <a:extLst>
              <a:ext uri="{FF2B5EF4-FFF2-40B4-BE49-F238E27FC236}">
                <a16:creationId xmlns:a16="http://schemas.microsoft.com/office/drawing/2014/main" id="{CC452AB3-D1D0-2F4D-84BE-2B5F84774D80}"/>
              </a:ext>
            </a:extLst>
          </p:cNvPr>
          <p:cNvSpPr txBox="1"/>
          <p:nvPr/>
        </p:nvSpPr>
        <p:spPr>
          <a:xfrm>
            <a:off x="1919536" y="4581129"/>
            <a:ext cx="842751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ure 2. </a:t>
            </a:r>
            <a:r>
              <a:rPr lang="en-US" dirty="0"/>
              <a:t>Gating strategy used for flow cytometry analysis of </a:t>
            </a:r>
            <a:r>
              <a:rPr lang="en-US" dirty="0">
                <a:cs typeface="Arial" pitchFamily="34" charset="0"/>
              </a:rPr>
              <a:t>NF-</a:t>
            </a:r>
            <a:r>
              <a:rPr lang="en-US" dirty="0" err="1">
                <a:cs typeface="Arial" pitchFamily="34" charset="0"/>
              </a:rPr>
              <a:t>κB</a:t>
            </a:r>
            <a:r>
              <a:rPr lang="en-US" dirty="0">
                <a:cs typeface="Arial" pitchFamily="34" charset="0"/>
              </a:rPr>
              <a:t> activation</a:t>
            </a:r>
            <a:r>
              <a:rPr lang="es-UY" dirty="0"/>
              <a:t>. </a:t>
            </a:r>
            <a:r>
              <a:rPr lang="en-US" dirty="0">
                <a:cs typeface="Arial" pitchFamily="34" charset="0"/>
              </a:rPr>
              <a:t>Representative analysis of H460-NF-κB-GFP cells is shown. Cells were cultured without (</a:t>
            </a:r>
            <a:r>
              <a:rPr lang="en-US" dirty="0" err="1">
                <a:cs typeface="Arial" pitchFamily="34" charset="0"/>
              </a:rPr>
              <a:t>Unstimulated</a:t>
            </a:r>
            <a:r>
              <a:rPr lang="en-US" dirty="0">
                <a:cs typeface="Arial" pitchFamily="34" charset="0"/>
              </a:rPr>
              <a:t> condition: Control + PI) or with TNF-α (Stimulated condition: Stimulated sample + PI). Cell population was selected in a Forward Side (</a:t>
            </a:r>
            <a:r>
              <a:rPr lang="es-ES" dirty="0"/>
              <a:t>Log FSC-A</a:t>
            </a:r>
            <a:r>
              <a:rPr lang="en-US" dirty="0">
                <a:cs typeface="Arial" pitchFamily="34" charset="0"/>
              </a:rPr>
              <a:t>) versus Side Scatter (</a:t>
            </a:r>
            <a:r>
              <a:rPr lang="es-ES" dirty="0"/>
              <a:t>Log SSC-A</a:t>
            </a:r>
            <a:r>
              <a:rPr lang="en-US" dirty="0">
                <a:cs typeface="Arial" pitchFamily="34" charset="0"/>
              </a:rPr>
              <a:t>) dot plot (A). This region was applied to a FSC Area vs. FSC Height dot plot to exclude cell aggregates (B). Finally, the percentage of GFP+ cells was analyzed from the GFP vs. PI dot plot considering only live cells exclusively (C). </a:t>
            </a:r>
            <a:endParaRPr lang="en-US" dirty="0"/>
          </a:p>
        </p:txBody>
      </p:sp>
      <p:sp>
        <p:nvSpPr>
          <p:cNvPr id="5" name="TextBox 27">
            <a:extLst>
              <a:ext uri="{FF2B5EF4-FFF2-40B4-BE49-F238E27FC236}">
                <a16:creationId xmlns:a16="http://schemas.microsoft.com/office/drawing/2014/main" id="{B238DBCC-44F1-DE40-81EB-A99E86E6533F}"/>
              </a:ext>
            </a:extLst>
          </p:cNvPr>
          <p:cNvSpPr txBox="1"/>
          <p:nvPr/>
        </p:nvSpPr>
        <p:spPr>
          <a:xfrm>
            <a:off x="4079776" y="-2738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6" name="TextBox 27">
            <a:extLst>
              <a:ext uri="{FF2B5EF4-FFF2-40B4-BE49-F238E27FC236}">
                <a16:creationId xmlns:a16="http://schemas.microsoft.com/office/drawing/2014/main" id="{45EFE129-C0F9-D342-93E5-350FCE10E458}"/>
              </a:ext>
            </a:extLst>
          </p:cNvPr>
          <p:cNvSpPr txBox="1"/>
          <p:nvPr/>
        </p:nvSpPr>
        <p:spPr>
          <a:xfrm>
            <a:off x="2567608" y="-3576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27">
            <a:extLst>
              <a:ext uri="{FF2B5EF4-FFF2-40B4-BE49-F238E27FC236}">
                <a16:creationId xmlns:a16="http://schemas.microsoft.com/office/drawing/2014/main" id="{8915216D-E2E8-574C-83E3-CBA52F057EFB}"/>
              </a:ext>
            </a:extLst>
          </p:cNvPr>
          <p:cNvSpPr txBox="1"/>
          <p:nvPr/>
        </p:nvSpPr>
        <p:spPr>
          <a:xfrm>
            <a:off x="5591944" y="-2738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833809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7</Words>
  <Application>Microsoft Macintosh PowerPoint</Application>
  <PresentationFormat>Widescreen</PresentationFormat>
  <Paragraphs>1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len Daghero Villanueva</dc:creator>
  <cp:lastModifiedBy>Hellen Daghero Villanueva</cp:lastModifiedBy>
  <cp:revision>1</cp:revision>
  <dcterms:created xsi:type="dcterms:W3CDTF">2020-12-23T15:00:25Z</dcterms:created>
  <dcterms:modified xsi:type="dcterms:W3CDTF">2020-12-23T15:01:19Z</dcterms:modified>
</cp:coreProperties>
</file>